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2065" autoAdjust="0"/>
    <p:restoredTop sz="94660"/>
  </p:normalViewPr>
  <p:slideViewPr>
    <p:cSldViewPr snapToGrid="0">
      <p:cViewPr varScale="1">
        <p:scale>
          <a:sx n="75" d="100"/>
          <a:sy n="75" d="100"/>
        </p:scale>
        <p:origin x="436" y="4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816C6E5-8125-17DF-77AD-F07E1DB4FB3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53C73008-78A1-9E2C-07D4-E7199906EC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B3A02AE-D7EC-9A06-D7CD-60A55FC3EB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38852-128B-4DFA-8FC1-AAB4E435C613}" type="datetimeFigureOut">
              <a:rPr kumimoji="1" lang="ja-JP" altLang="en-US" smtClean="0"/>
              <a:t>2022/9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F55252D-5ED2-B8A9-2E37-781D7D6CFA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F34AF84-C462-02C6-3A83-DF2D5FAF4F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E25EB-43E4-4309-8A42-72210FEF5E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13166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C97342A-426B-D08B-50BD-F84025E616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518A11D-59F1-0F41-73E4-8BB950D8F7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492D5ED-FE66-7C10-41E7-45A03409C9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38852-128B-4DFA-8FC1-AAB4E435C613}" type="datetimeFigureOut">
              <a:rPr kumimoji="1" lang="ja-JP" altLang="en-US" smtClean="0"/>
              <a:t>2022/9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E29E330-3FBB-B59F-F109-BCBA998A71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BC55860-0C9B-9881-F899-243F16D51E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E25EB-43E4-4309-8A42-72210FEF5E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213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B477F3E-5FFF-1032-14FC-615616EDED3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1708E8A-F911-CAD2-29C6-35D6C8695B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D1036E7-E474-22A9-BA6D-2D7E34029B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38852-128B-4DFA-8FC1-AAB4E435C613}" type="datetimeFigureOut">
              <a:rPr kumimoji="1" lang="ja-JP" altLang="en-US" smtClean="0"/>
              <a:t>2022/9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16B725C-829B-7998-5698-15A3987CFA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DEB039E-BB28-2D34-58BC-858FBF8138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E25EB-43E4-4309-8A42-72210FEF5E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03830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B3A8874-E5D8-4B3A-2440-EC3894C468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7838E34-4D18-7EA2-E6AF-D55317AC496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3C9A3BC-C23F-429C-E61F-5E2CBA961F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38852-128B-4DFA-8FC1-AAB4E435C613}" type="datetimeFigureOut">
              <a:rPr kumimoji="1" lang="ja-JP" altLang="en-US" smtClean="0"/>
              <a:t>2022/9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333C0A3-6265-D620-70C9-1D9E4CBE7B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A232D2A-5BE4-D0E0-54E0-8BB545922D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E25EB-43E4-4309-8A42-72210FEF5E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09851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2B974DC-71CD-DCB0-3429-FF4634EC49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3235789-557A-63CC-54C6-059640D8B4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7193325-B729-74B9-33F1-4A97B26D7E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38852-128B-4DFA-8FC1-AAB4E435C613}" type="datetimeFigureOut">
              <a:rPr kumimoji="1" lang="ja-JP" altLang="en-US" smtClean="0"/>
              <a:t>2022/9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D883AD4-BF44-A4A6-FD7B-6267A1949C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A6B5274-9A16-B961-FEE0-B168D8420B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E25EB-43E4-4309-8A42-72210FEF5E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05481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0D90820-11E4-C6AF-8ED5-8C7B71134D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29C5DB6-9AD5-3417-53BB-C8D70501B15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B68BD67-8EDF-BF70-E183-E1D3925C18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9BB66B8-CA84-58BB-43C9-9007BEF204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38852-128B-4DFA-8FC1-AAB4E435C613}" type="datetimeFigureOut">
              <a:rPr kumimoji="1" lang="ja-JP" altLang="en-US" smtClean="0"/>
              <a:t>2022/9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CCC9717-FED5-6DE7-E5BA-B4EC152F40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2CB140A-223B-897A-E027-F294CF0628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E25EB-43E4-4309-8A42-72210FEF5E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19277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B8C3212-E361-691C-4D12-C149BD80A5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B0DC65F-E7E8-062B-3735-0E83084813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D140F40-E253-7AA8-C9D7-307050C2EB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4CF53B5-031A-D5D3-C4B5-8822804F52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EE5158C-31BC-1C1A-FFC0-F51E74B6923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1259966-7876-7C7B-3553-FE85E29E36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38852-128B-4DFA-8FC1-AAB4E435C613}" type="datetimeFigureOut">
              <a:rPr kumimoji="1" lang="ja-JP" altLang="en-US" smtClean="0"/>
              <a:t>2022/9/3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1986322-9265-5E97-FDE1-353653E614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48A67E81-A7EB-EDAF-126B-E36D3FCEFB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E25EB-43E4-4309-8A42-72210FEF5E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33271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B481E47-E716-C428-EAA5-117E8D41E9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4F9376A-D004-E4F1-3A1D-E7A46FCA2D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38852-128B-4DFA-8FC1-AAB4E435C613}" type="datetimeFigureOut">
              <a:rPr kumimoji="1" lang="ja-JP" altLang="en-US" smtClean="0"/>
              <a:t>2022/9/3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EFF0C82-C37A-D7DC-CC3D-7C0F0D5C93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01CF6FD9-6C50-06BE-3CDC-9FF97A67AF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E25EB-43E4-4309-8A42-72210FEF5E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53532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F8F6349-BBFC-BB6D-F10D-FA0E3A6DAC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38852-128B-4DFA-8FC1-AAB4E435C613}" type="datetimeFigureOut">
              <a:rPr kumimoji="1" lang="ja-JP" altLang="en-US" smtClean="0"/>
              <a:t>2022/9/3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F89DEC1-6418-F773-64AF-37F18674FB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0804DF38-6E9D-FAAF-074C-74D1166BA0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E25EB-43E4-4309-8A42-72210FEF5E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24949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1DB90A4-8541-E650-1921-A02A866977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F183B49-E622-6482-1E09-B4863028CFE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6BBC2A5-6D2D-D690-110C-21DFB37A4B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F157E1D-1E6B-D2AD-A2FF-470A105BF5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38852-128B-4DFA-8FC1-AAB4E435C613}" type="datetimeFigureOut">
              <a:rPr kumimoji="1" lang="ja-JP" altLang="en-US" smtClean="0"/>
              <a:t>2022/9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1B9DF73-DD7A-18F0-F159-11D0F46EA7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2ED82D3-2B67-B524-733D-093DB6AE4B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E25EB-43E4-4309-8A42-72210FEF5E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01834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BBB98A0-18FA-D4C0-B8C4-F2FD9DE5CD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D3EA76A-B103-73F6-B0D4-7FE100D08E9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587993E-AB9C-3F66-7AA3-DF2A00E8A9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76A338D-CAF5-E0B6-69C4-B3478544D1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38852-128B-4DFA-8FC1-AAB4E435C613}" type="datetimeFigureOut">
              <a:rPr kumimoji="1" lang="ja-JP" altLang="en-US" smtClean="0"/>
              <a:t>2022/9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FD7DA92-3FE9-DD6A-296D-B8BA35453C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056AA15-457F-F723-C56D-A7B8E7DA6F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E25EB-43E4-4309-8A42-72210FEF5E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0901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9EC53808-27DD-2D64-1AB6-2D5BAAE007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E8276FC-AD3B-6E49-AF7F-BC523C59C0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27F2C24-F81A-AE26-F16C-A864D70189A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538852-128B-4DFA-8FC1-AAB4E435C613}" type="datetimeFigureOut">
              <a:rPr kumimoji="1" lang="ja-JP" altLang="en-US" smtClean="0"/>
              <a:t>2022/9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DB28E6A-437A-2787-34BA-482E19B223D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CDEC684-064E-4ED1-614A-662AC1B1FDB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8E25EB-43E4-4309-8A42-72210FEF5E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10312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9455F55C-B654-4046-AFF6-7B735E3880B0}"/>
              </a:ext>
            </a:extLst>
          </p:cNvPr>
          <p:cNvSpPr txBox="1"/>
          <p:nvPr/>
        </p:nvSpPr>
        <p:spPr>
          <a:xfrm>
            <a:off x="377288" y="6207222"/>
            <a:ext cx="732474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rtl="0">
              <a:defRPr sz="140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-Fig. 1. Forms of packaging of oysters sold commercially in Japanese supermarkets.</a:t>
            </a:r>
          </a:p>
          <a:p>
            <a:pPr rtl="0">
              <a:defRPr sz="140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) Packed in sterile seawater, B) packed in trays (without seawater).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63B7C083-6AE9-F865-DE50-C4E0EBED28F3}"/>
              </a:ext>
            </a:extLst>
          </p:cNvPr>
          <p:cNvSpPr txBox="1"/>
          <p:nvPr/>
        </p:nvSpPr>
        <p:spPr>
          <a:xfrm>
            <a:off x="67013" y="3675332"/>
            <a:ext cx="4992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 sz="140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400" b="0" i="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(B)</a:t>
            </a:r>
            <a:endParaRPr lang="ja-JP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4115B29E-8242-688D-5319-EB55F4AC60C2}"/>
              </a:ext>
            </a:extLst>
          </p:cNvPr>
          <p:cNvSpPr txBox="1"/>
          <p:nvPr/>
        </p:nvSpPr>
        <p:spPr>
          <a:xfrm>
            <a:off x="151606" y="97876"/>
            <a:ext cx="4992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 sz="140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400" b="0" i="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(A)</a:t>
            </a:r>
            <a:endParaRPr lang="ja-JP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53" name="図 52" descr="テキスト が含まれている画像&#10;&#10;自動的に生成された説明">
            <a:extLst>
              <a:ext uri="{FF2B5EF4-FFF2-40B4-BE49-F238E27FC236}">
                <a16:creationId xmlns:a16="http://schemas.microsoft.com/office/drawing/2014/main" id="{125AFD77-953E-2618-99BE-8353F53E68F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20" t="-1974" r="9912" b="32822"/>
          <a:stretch/>
        </p:blipFill>
        <p:spPr>
          <a:xfrm>
            <a:off x="4666672" y="33323"/>
            <a:ext cx="3566007" cy="2647124"/>
          </a:xfrm>
          <a:prstGeom prst="rect">
            <a:avLst/>
          </a:prstGeom>
        </p:spPr>
      </p:pic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492B55CE-6B26-4E6C-6A74-7784F8749CE4}"/>
              </a:ext>
            </a:extLst>
          </p:cNvPr>
          <p:cNvSpPr/>
          <p:nvPr/>
        </p:nvSpPr>
        <p:spPr>
          <a:xfrm>
            <a:off x="5085331" y="1410996"/>
            <a:ext cx="763019" cy="478404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F26A0C31-0E3A-FA8F-9F37-43033C1FE686}"/>
              </a:ext>
            </a:extLst>
          </p:cNvPr>
          <p:cNvSpPr/>
          <p:nvPr/>
        </p:nvSpPr>
        <p:spPr>
          <a:xfrm>
            <a:off x="5085331" y="1962975"/>
            <a:ext cx="763019" cy="38970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8C28168D-B35D-2EF3-6E28-0A753F1A0CF1}"/>
              </a:ext>
            </a:extLst>
          </p:cNvPr>
          <p:cNvGrpSpPr/>
          <p:nvPr/>
        </p:nvGrpSpPr>
        <p:grpSpPr>
          <a:xfrm>
            <a:off x="1103962" y="-1218657"/>
            <a:ext cx="3373317" cy="3899103"/>
            <a:chOff x="1103962" y="-1218657"/>
            <a:chExt cx="3373317" cy="3899103"/>
          </a:xfrm>
        </p:grpSpPr>
        <p:pic>
          <p:nvPicPr>
            <p:cNvPr id="57" name="図 56" descr="手紙 が含まれている画像&#10;&#10;自動的に生成された説明">
              <a:extLst>
                <a:ext uri="{FF2B5EF4-FFF2-40B4-BE49-F238E27FC236}">
                  <a16:creationId xmlns:a16="http://schemas.microsoft.com/office/drawing/2014/main" id="{1133B301-2561-5483-E0AA-5F7101A4B04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381" t="-36644" r="13466" b="33153"/>
            <a:stretch/>
          </p:blipFill>
          <p:spPr>
            <a:xfrm>
              <a:off x="1103962" y="-1218657"/>
              <a:ext cx="3373317" cy="3899103"/>
            </a:xfrm>
            <a:prstGeom prst="rect">
              <a:avLst/>
            </a:prstGeom>
          </p:spPr>
        </p:pic>
        <p:sp>
          <p:nvSpPr>
            <p:cNvPr id="3" name="正方形/長方形 2">
              <a:extLst>
                <a:ext uri="{FF2B5EF4-FFF2-40B4-BE49-F238E27FC236}">
                  <a16:creationId xmlns:a16="http://schemas.microsoft.com/office/drawing/2014/main" id="{F6BFE0C3-F8A0-F6CD-6C69-FD6FD0455618}"/>
                </a:ext>
              </a:extLst>
            </p:cNvPr>
            <p:cNvSpPr/>
            <p:nvPr/>
          </p:nvSpPr>
          <p:spPr>
            <a:xfrm>
              <a:off x="1310826" y="1904326"/>
              <a:ext cx="1089474" cy="619799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6" name="正方形/長方形 15">
              <a:extLst>
                <a:ext uri="{FF2B5EF4-FFF2-40B4-BE49-F238E27FC236}">
                  <a16:creationId xmlns:a16="http://schemas.microsoft.com/office/drawing/2014/main" id="{E2E6880B-18EC-18A2-7B26-8E27FC51F209}"/>
                </a:ext>
              </a:extLst>
            </p:cNvPr>
            <p:cNvSpPr/>
            <p:nvPr/>
          </p:nvSpPr>
          <p:spPr>
            <a:xfrm>
              <a:off x="1491801" y="480349"/>
              <a:ext cx="460824" cy="478404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7" name="正方形/長方形 16">
              <a:extLst>
                <a:ext uri="{FF2B5EF4-FFF2-40B4-BE49-F238E27FC236}">
                  <a16:creationId xmlns:a16="http://schemas.microsoft.com/office/drawing/2014/main" id="{87CD5CA6-7910-ABA8-DE2A-C6E5812BF9E0}"/>
                </a:ext>
              </a:extLst>
            </p:cNvPr>
            <p:cNvSpPr/>
            <p:nvPr/>
          </p:nvSpPr>
          <p:spPr>
            <a:xfrm>
              <a:off x="1310826" y="1524000"/>
              <a:ext cx="860874" cy="3654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0" name="正方形/長方形 19">
              <a:extLst>
                <a:ext uri="{FF2B5EF4-FFF2-40B4-BE49-F238E27FC236}">
                  <a16:creationId xmlns:a16="http://schemas.microsoft.com/office/drawing/2014/main" id="{43FAC657-523B-D85A-6896-0EEB4F106324}"/>
                </a:ext>
              </a:extLst>
            </p:cNvPr>
            <p:cNvSpPr/>
            <p:nvPr/>
          </p:nvSpPr>
          <p:spPr>
            <a:xfrm>
              <a:off x="2400300" y="2256567"/>
              <a:ext cx="809625" cy="181833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C1271546-7E34-559F-78BA-67C789131EAC}"/>
              </a:ext>
            </a:extLst>
          </p:cNvPr>
          <p:cNvSpPr/>
          <p:nvPr/>
        </p:nvSpPr>
        <p:spPr>
          <a:xfrm>
            <a:off x="5904938" y="2157825"/>
            <a:ext cx="1257862" cy="19485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0F109BC8-075D-22DF-645F-C7B2390FB797}"/>
              </a:ext>
            </a:extLst>
          </p:cNvPr>
          <p:cNvGrpSpPr/>
          <p:nvPr/>
        </p:nvGrpSpPr>
        <p:grpSpPr>
          <a:xfrm>
            <a:off x="8331469" y="97876"/>
            <a:ext cx="3459299" cy="1243351"/>
            <a:chOff x="8331469" y="97876"/>
            <a:chExt cx="3459299" cy="1243351"/>
          </a:xfrm>
        </p:grpSpPr>
        <p:pic>
          <p:nvPicPr>
            <p:cNvPr id="36" name="図 35" descr="テキスト&#10;&#10;中程度の精度で自動的に生成された説明">
              <a:extLst>
                <a:ext uri="{FF2B5EF4-FFF2-40B4-BE49-F238E27FC236}">
                  <a16:creationId xmlns:a16="http://schemas.microsoft.com/office/drawing/2014/main" id="{1A30385A-2AE3-CDED-33AF-BC3CA7A7F88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71" t="23839" r="13333" b="35380"/>
            <a:stretch/>
          </p:blipFill>
          <p:spPr>
            <a:xfrm>
              <a:off x="8331469" y="97876"/>
              <a:ext cx="3459299" cy="1243351"/>
            </a:xfrm>
            <a:prstGeom prst="rect">
              <a:avLst/>
            </a:prstGeom>
          </p:spPr>
        </p:pic>
        <p:sp>
          <p:nvSpPr>
            <p:cNvPr id="22" name="正方形/長方形 21">
              <a:extLst>
                <a:ext uri="{FF2B5EF4-FFF2-40B4-BE49-F238E27FC236}">
                  <a16:creationId xmlns:a16="http://schemas.microsoft.com/office/drawing/2014/main" id="{24F2E066-1C41-1F2A-8D0E-31495881B16C}"/>
                </a:ext>
              </a:extLst>
            </p:cNvPr>
            <p:cNvSpPr/>
            <p:nvPr/>
          </p:nvSpPr>
          <p:spPr>
            <a:xfrm>
              <a:off x="9778551" y="823386"/>
              <a:ext cx="921648" cy="261479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3" name="正方形/長方形 22">
              <a:extLst>
                <a:ext uri="{FF2B5EF4-FFF2-40B4-BE49-F238E27FC236}">
                  <a16:creationId xmlns:a16="http://schemas.microsoft.com/office/drawing/2014/main" id="{CB8A0356-A872-AE8F-71A9-38C3D28C0B42}"/>
                </a:ext>
              </a:extLst>
            </p:cNvPr>
            <p:cNvSpPr/>
            <p:nvPr/>
          </p:nvSpPr>
          <p:spPr>
            <a:xfrm>
              <a:off x="10800084" y="203744"/>
              <a:ext cx="877566" cy="619641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F978F7CA-BE6A-A17C-1C83-220F8980AD49}"/>
              </a:ext>
            </a:extLst>
          </p:cNvPr>
          <p:cNvGrpSpPr/>
          <p:nvPr/>
        </p:nvGrpSpPr>
        <p:grpSpPr>
          <a:xfrm>
            <a:off x="7328885" y="3531435"/>
            <a:ext cx="3776321" cy="3097307"/>
            <a:chOff x="7328885" y="3531435"/>
            <a:chExt cx="3776321" cy="3097307"/>
          </a:xfrm>
        </p:grpSpPr>
        <p:pic>
          <p:nvPicPr>
            <p:cNvPr id="38" name="図 37" descr="手紙&#10;&#10;低い精度で自動的に生成された説明">
              <a:extLst>
                <a:ext uri="{FF2B5EF4-FFF2-40B4-BE49-F238E27FC236}">
                  <a16:creationId xmlns:a16="http://schemas.microsoft.com/office/drawing/2014/main" id="{71FE3EB2-226F-8412-7BB2-C1E9ED17462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278" t="5913" r="16282" b="32365"/>
            <a:stretch/>
          </p:blipFill>
          <p:spPr>
            <a:xfrm>
              <a:off x="7328885" y="3531435"/>
              <a:ext cx="3776321" cy="3097307"/>
            </a:xfrm>
            <a:prstGeom prst="rect">
              <a:avLst/>
            </a:prstGeom>
          </p:spPr>
        </p:pic>
        <p:sp>
          <p:nvSpPr>
            <p:cNvPr id="29" name="正方形/長方形 28">
              <a:extLst>
                <a:ext uri="{FF2B5EF4-FFF2-40B4-BE49-F238E27FC236}">
                  <a16:creationId xmlns:a16="http://schemas.microsoft.com/office/drawing/2014/main" id="{FDB10FF0-6DAF-DB5D-3B7F-49E4C1792C3A}"/>
                </a:ext>
              </a:extLst>
            </p:cNvPr>
            <p:cNvSpPr/>
            <p:nvPr/>
          </p:nvSpPr>
          <p:spPr>
            <a:xfrm rot="174374">
              <a:off x="9215960" y="5230364"/>
              <a:ext cx="1421459" cy="859738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49A1CBF7-FDA9-41FC-FC48-7E3E94AD9B72}"/>
              </a:ext>
            </a:extLst>
          </p:cNvPr>
          <p:cNvGrpSpPr/>
          <p:nvPr/>
        </p:nvGrpSpPr>
        <p:grpSpPr>
          <a:xfrm>
            <a:off x="1173765" y="3535644"/>
            <a:ext cx="4236191" cy="2531292"/>
            <a:chOff x="1173765" y="3535644"/>
            <a:chExt cx="4236191" cy="2531292"/>
          </a:xfrm>
        </p:grpSpPr>
        <p:pic>
          <p:nvPicPr>
            <p:cNvPr id="47" name="図 46" descr="カレンダー が含まれている画像&#10;&#10;自動的に生成された説明">
              <a:extLst>
                <a:ext uri="{FF2B5EF4-FFF2-40B4-BE49-F238E27FC236}">
                  <a16:creationId xmlns:a16="http://schemas.microsoft.com/office/drawing/2014/main" id="{63D7C4E9-DA35-E795-9299-70C4CDAFB4E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235" t="4283" r="19011" b="40939"/>
            <a:stretch/>
          </p:blipFill>
          <p:spPr>
            <a:xfrm>
              <a:off x="1173765" y="3535644"/>
              <a:ext cx="4236191" cy="2531292"/>
            </a:xfrm>
            <a:prstGeom prst="rect">
              <a:avLst/>
            </a:prstGeom>
          </p:spPr>
        </p:pic>
        <p:sp>
          <p:nvSpPr>
            <p:cNvPr id="30" name="正方形/長方形 29">
              <a:extLst>
                <a:ext uri="{FF2B5EF4-FFF2-40B4-BE49-F238E27FC236}">
                  <a16:creationId xmlns:a16="http://schemas.microsoft.com/office/drawing/2014/main" id="{70F8FA67-8775-9476-546D-DDE18E1C97C3}"/>
                </a:ext>
              </a:extLst>
            </p:cNvPr>
            <p:cNvSpPr/>
            <p:nvPr/>
          </p:nvSpPr>
          <p:spPr>
            <a:xfrm>
              <a:off x="3829049" y="4876801"/>
              <a:ext cx="1256282" cy="8128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CD896356-06B6-E32A-9A16-6D02446C69FF}"/>
              </a:ext>
            </a:extLst>
          </p:cNvPr>
          <p:cNvGrpSpPr/>
          <p:nvPr/>
        </p:nvGrpSpPr>
        <p:grpSpPr>
          <a:xfrm>
            <a:off x="8331472" y="1398653"/>
            <a:ext cx="3459297" cy="1395588"/>
            <a:chOff x="8331472" y="1398653"/>
            <a:chExt cx="3459297" cy="1395588"/>
          </a:xfrm>
        </p:grpSpPr>
        <p:pic>
          <p:nvPicPr>
            <p:cNvPr id="40" name="図 39" descr="テキスト&#10;&#10;自動的に生成された説明">
              <a:extLst>
                <a:ext uri="{FF2B5EF4-FFF2-40B4-BE49-F238E27FC236}">
                  <a16:creationId xmlns:a16="http://schemas.microsoft.com/office/drawing/2014/main" id="{38351ABD-6661-94F3-58B3-0CCECE95C59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173" t="-202" r="15642" b="10622"/>
            <a:stretch/>
          </p:blipFill>
          <p:spPr>
            <a:xfrm rot="16200000">
              <a:off x="9363327" y="366798"/>
              <a:ext cx="1395588" cy="3459297"/>
            </a:xfrm>
            <a:prstGeom prst="rect">
              <a:avLst/>
            </a:prstGeom>
          </p:spPr>
        </p:pic>
        <p:sp>
          <p:nvSpPr>
            <p:cNvPr id="24" name="正方形/長方形 23">
              <a:extLst>
                <a:ext uri="{FF2B5EF4-FFF2-40B4-BE49-F238E27FC236}">
                  <a16:creationId xmlns:a16="http://schemas.microsoft.com/office/drawing/2014/main" id="{5FDDA84C-217B-BB39-3E23-4B109C23F936}"/>
                </a:ext>
              </a:extLst>
            </p:cNvPr>
            <p:cNvSpPr/>
            <p:nvPr/>
          </p:nvSpPr>
          <p:spPr>
            <a:xfrm>
              <a:off x="9162769" y="2309383"/>
              <a:ext cx="1244882" cy="214742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5" name="正方形/長方形 24">
              <a:extLst>
                <a:ext uri="{FF2B5EF4-FFF2-40B4-BE49-F238E27FC236}">
                  <a16:creationId xmlns:a16="http://schemas.microsoft.com/office/drawing/2014/main" id="{CCD1EF6F-121B-CEC6-0452-7C7757F03EF5}"/>
                </a:ext>
              </a:extLst>
            </p:cNvPr>
            <p:cNvSpPr/>
            <p:nvPr/>
          </p:nvSpPr>
          <p:spPr>
            <a:xfrm rot="16200000">
              <a:off x="10657817" y="1917262"/>
              <a:ext cx="547860" cy="312582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6" name="正方形/長方形 25">
              <a:extLst>
                <a:ext uri="{FF2B5EF4-FFF2-40B4-BE49-F238E27FC236}">
                  <a16:creationId xmlns:a16="http://schemas.microsoft.com/office/drawing/2014/main" id="{5E78E600-9006-FF7B-57AF-3D8BF4A25474}"/>
                </a:ext>
              </a:extLst>
            </p:cNvPr>
            <p:cNvSpPr/>
            <p:nvPr/>
          </p:nvSpPr>
          <p:spPr>
            <a:xfrm rot="16200000">
              <a:off x="11074769" y="1917474"/>
              <a:ext cx="666609" cy="375242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5" name="正方形/長方形 34">
              <a:extLst>
                <a:ext uri="{FF2B5EF4-FFF2-40B4-BE49-F238E27FC236}">
                  <a16:creationId xmlns:a16="http://schemas.microsoft.com/office/drawing/2014/main" id="{00DA098B-C14D-5377-EE79-CDA31388F382}"/>
                </a:ext>
              </a:extLst>
            </p:cNvPr>
            <p:cNvSpPr/>
            <p:nvPr/>
          </p:nvSpPr>
          <p:spPr>
            <a:xfrm rot="16200000">
              <a:off x="10300022" y="1927081"/>
              <a:ext cx="547860" cy="252494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51533FB0-D365-06F2-2D31-A7F448074840}"/>
              </a:ext>
            </a:extLst>
          </p:cNvPr>
          <p:cNvSpPr/>
          <p:nvPr/>
        </p:nvSpPr>
        <p:spPr>
          <a:xfrm>
            <a:off x="6062556" y="1620189"/>
            <a:ext cx="702310" cy="27567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38EB00F4-3FC7-E73F-F01A-4AB64387ACC5}"/>
              </a:ext>
            </a:extLst>
          </p:cNvPr>
          <p:cNvSpPr/>
          <p:nvPr/>
        </p:nvSpPr>
        <p:spPr>
          <a:xfrm>
            <a:off x="3254670" y="2044861"/>
            <a:ext cx="784990" cy="385072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27166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6</TotalTime>
  <Words>37</Words>
  <Application>Microsoft Office PowerPoint</Application>
  <PresentationFormat>ワイド画面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崎 渉</dc:creator>
  <cp:lastModifiedBy>山崎 渉</cp:lastModifiedBy>
  <cp:revision>64</cp:revision>
  <dcterms:created xsi:type="dcterms:W3CDTF">2022-06-06T03:14:54Z</dcterms:created>
  <dcterms:modified xsi:type="dcterms:W3CDTF">2022-09-30T10:19:00Z</dcterms:modified>
</cp:coreProperties>
</file>